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EB1264-4DE8-436E-803B-43301E8690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B13AB-9091-4277-8B5C-49409F4E33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12567-15BE-4BCE-A53B-5E76D3C33E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BA2139-8C90-4505-BC6E-C84BF0BED0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46243-4EF6-4038-9F49-346D931869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36054-BD96-482E-B517-7061E809CC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21B67-E3F0-49BF-B5DB-CF209D40E6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9C47E7-D95F-42BD-95D0-0D2ACB31DB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9A3D5-EBD6-4BA9-97CF-FB6DFBD0AC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3A66C-B62D-48F1-A828-C9F9084906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DDF06C-9B07-4988-957C-4D26662D9E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98492-9549-4618-95FA-73D7F8A4E3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D75F59-FAB1-4E34-AE8F-499F6CB2EB16}" type="slidenum"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00"/>
          <p:cNvGrpSpPr/>
          <p:nvPr/>
        </p:nvGrpSpPr>
        <p:grpSpPr>
          <a:xfrm>
            <a:off x="3780000" y="117360"/>
            <a:ext cx="3240000" cy="2230200"/>
            <a:chOff x="3780000" y="117360"/>
            <a:chExt cx="3240000" cy="2230200"/>
          </a:xfrm>
        </p:grpSpPr>
        <p:pic>
          <p:nvPicPr>
            <p:cNvPr id="42" name="Picture 46" descr=""/>
            <p:cNvPicPr/>
            <p:nvPr/>
          </p:nvPicPr>
          <p:blipFill>
            <a:blip r:embed="rId1"/>
            <a:srcRect l="0" t="3298" r="5273" b="0"/>
            <a:stretch/>
          </p:blipFill>
          <p:spPr>
            <a:xfrm>
              <a:off x="3780000" y="620280"/>
              <a:ext cx="3240000" cy="1727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 Box 82"/>
            <p:cNvSpPr/>
            <p:nvPr/>
          </p:nvSpPr>
          <p:spPr>
            <a:xfrm>
              <a:off x="3923640" y="117360"/>
              <a:ext cx="338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  <p:grpSp>
        <p:nvGrpSpPr>
          <p:cNvPr id="44" name="Group 102"/>
          <p:cNvGrpSpPr/>
          <p:nvPr/>
        </p:nvGrpSpPr>
        <p:grpSpPr>
          <a:xfrm>
            <a:off x="110520" y="2708280"/>
            <a:ext cx="3597480" cy="2161800"/>
            <a:chOff x="110520" y="2708280"/>
            <a:chExt cx="3597480" cy="2161800"/>
          </a:xfrm>
        </p:grpSpPr>
        <p:pic>
          <p:nvPicPr>
            <p:cNvPr id="45" name="Picture 43" descr=""/>
            <p:cNvPicPr/>
            <p:nvPr/>
          </p:nvPicPr>
          <p:blipFill>
            <a:blip r:embed="rId2"/>
            <a:srcRect l="2580" t="4609" r="9030" b="1536"/>
            <a:stretch/>
          </p:blipFill>
          <p:spPr>
            <a:xfrm>
              <a:off x="650520" y="3145680"/>
              <a:ext cx="1479600" cy="1724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48" descr=""/>
            <p:cNvPicPr/>
            <p:nvPr/>
          </p:nvPicPr>
          <p:blipFill>
            <a:blip r:embed="rId3"/>
            <a:srcRect l="2769" t="4609" r="9691" b="1536"/>
            <a:stretch/>
          </p:blipFill>
          <p:spPr>
            <a:xfrm>
              <a:off x="2228400" y="3145680"/>
              <a:ext cx="1479600" cy="172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 Box 85"/>
            <p:cNvSpPr/>
            <p:nvPr/>
          </p:nvSpPr>
          <p:spPr>
            <a:xfrm>
              <a:off x="110520" y="270828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  <p:sp>
        <p:nvSpPr>
          <p:cNvPr id="48" name="Text Box 39"/>
          <p:cNvSpPr/>
          <p:nvPr/>
        </p:nvSpPr>
        <p:spPr>
          <a:xfrm>
            <a:off x="179280" y="5805360"/>
            <a:ext cx="83534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Figure S2. Eosinophils are recruited to the airway by low-dose </a:t>
            </a:r>
            <a:r>
              <a:rPr b="1" i="1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Acanthamoeba</a:t>
            </a:r>
            <a:r>
              <a:rPr b="1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 infection.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 (A) Airway resistance values in response to methacholine (0 to 50 mg/ml). (B) Differential cell count in 800 µl BAL after Diff-Quik staining. (C) Total and </a:t>
            </a:r>
            <a:r>
              <a:rPr b="0" i="1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Acanthamoeba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-specific IgE levels were measured in serum by ELISA. (*</a:t>
            </a:r>
            <a:r>
              <a:rPr b="0" i="1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 &lt; 0.05, **</a:t>
            </a:r>
            <a:r>
              <a:rPr b="0" i="1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 &lt; 0.01, ***</a:t>
            </a:r>
            <a:r>
              <a:rPr b="0" i="1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 &lt; 0.001). 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4"/>
          <a:srcRect l="0" t="0" r="9895" b="8527"/>
          <a:stretch/>
        </p:blipFill>
        <p:spPr>
          <a:xfrm>
            <a:off x="468360" y="404640"/>
            <a:ext cx="3095640" cy="2183040"/>
          </a:xfrm>
          <a:prstGeom prst="rect">
            <a:avLst/>
          </a:prstGeom>
          <a:ln w="0">
            <a:noFill/>
          </a:ln>
        </p:spPr>
      </p:pic>
      <p:sp>
        <p:nvSpPr>
          <p:cNvPr id="50" name="Text Box 83"/>
          <p:cNvSpPr/>
          <p:nvPr/>
        </p:nvSpPr>
        <p:spPr>
          <a:xfrm>
            <a:off x="108000" y="189000"/>
            <a:ext cx="42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28T00:46:27Z</dcterms:created>
  <dc:creator>Yu Hak Sun</dc:creator>
  <dc:description/>
  <dc:language>en-US</dc:language>
  <cp:lastModifiedBy>Yu Hak Sun</cp:lastModifiedBy>
  <dcterms:modified xsi:type="dcterms:W3CDTF">2014-02-28T00:47:59Z</dcterms:modified>
  <cp:revision>1</cp:revision>
  <dc:subject/>
  <dc:title>슬라이드 1</dc:title>
</cp:coreProperties>
</file>